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87" d="100"/>
          <a:sy n="87" d="100"/>
        </p:scale>
        <p:origin x="1266" y="-16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6019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9963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6654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3326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0616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8157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9439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5427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5095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9106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1155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6203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 flipH="1">
            <a:off x="443854" y="6202578"/>
            <a:ext cx="565411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ead mapping for the 3 barley genotypes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etwee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6.28 and 77.70% of the reads were associated to annotated genes (a mean of 76.9%,  76.6% and  76.7% respectively for GP, M4 and M5 barley cultivars). Statistical analysis was performed with Wilcoxon’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est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hen comparing the percentages of assigned reads samples per cultivar, the difference between the means is not statistically significant. The three cultivars mapped similarly onto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orex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eference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orex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eference has a higher version (v2) than GP reference (v1). The reference annotation should be better f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orex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061" y="2234766"/>
            <a:ext cx="4500618" cy="36942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07419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3</TotalTime>
  <Words>109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a Dellagi</dc:creator>
  <cp:lastModifiedBy>Alia Dellagi</cp:lastModifiedBy>
  <cp:revision>30</cp:revision>
  <cp:lastPrinted>2021-09-15T09:10:34Z</cp:lastPrinted>
  <dcterms:created xsi:type="dcterms:W3CDTF">2021-04-15T18:38:08Z</dcterms:created>
  <dcterms:modified xsi:type="dcterms:W3CDTF">2021-11-22T17:18:26Z</dcterms:modified>
</cp:coreProperties>
</file>